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93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297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079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9917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1029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2148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9318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5408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2333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8933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650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0359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A2F40-8979-42E0-95FA-B62644F6DA73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84772-58F8-4B9E-8851-D581B05673B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236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0711337"/>
              </p:ext>
            </p:extLst>
          </p:nvPr>
        </p:nvGraphicFramePr>
        <p:xfrm>
          <a:off x="820881" y="2531085"/>
          <a:ext cx="10335494" cy="259163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583874">
                  <a:extLst>
                    <a:ext uri="{9D8B030D-6E8A-4147-A177-3AD203B41FA5}">
                      <a16:colId xmlns:a16="http://schemas.microsoft.com/office/drawing/2014/main" val="2897457995"/>
                    </a:ext>
                  </a:extLst>
                </a:gridCol>
                <a:gridCol w="2583874">
                  <a:extLst>
                    <a:ext uri="{9D8B030D-6E8A-4147-A177-3AD203B41FA5}">
                      <a16:colId xmlns:a16="http://schemas.microsoft.com/office/drawing/2014/main" val="2555513454"/>
                    </a:ext>
                  </a:extLst>
                </a:gridCol>
                <a:gridCol w="3740671">
                  <a:extLst>
                    <a:ext uri="{9D8B030D-6E8A-4147-A177-3AD203B41FA5}">
                      <a16:colId xmlns:a16="http://schemas.microsoft.com/office/drawing/2014/main" val="3745530523"/>
                    </a:ext>
                  </a:extLst>
                </a:gridCol>
                <a:gridCol w="1427075">
                  <a:extLst>
                    <a:ext uri="{9D8B030D-6E8A-4147-A177-3AD203B41FA5}">
                      <a16:colId xmlns:a16="http://schemas.microsoft.com/office/drawing/2014/main" val="3217251295"/>
                    </a:ext>
                  </a:extLst>
                </a:gridCol>
              </a:tblGrid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en-GB" sz="1600" b="1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 coefficient</a:t>
                      </a:r>
                      <a:endParaRPr lang="en-GB" sz="1600" b="1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  <a:endParaRPr lang="en-GB" sz="1600" b="1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GB" sz="1600" b="1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6836966"/>
                  </a:ext>
                </a:extLst>
              </a:tr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s quartile 2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196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081 to 0.042]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9088869"/>
                  </a:ext>
                </a:extLst>
              </a:tr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s quartile 3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493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112 to 0.013]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9453942"/>
                  </a:ext>
                </a:extLst>
              </a:tr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s quartile 4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154 to -0.026]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4301076"/>
                  </a:ext>
                </a:extLst>
              </a:tr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12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0026 to 0.0003]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19918376"/>
                  </a:ext>
                </a:extLst>
              </a:tr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 </a:t>
                      </a:r>
                      <a:r>
                        <a:rPr lang="en-US" sz="16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female</a:t>
                      </a: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473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092 to -0.003]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6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2737639"/>
                  </a:ext>
                </a:extLst>
              </a:tr>
              <a:tr h="32388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betes duration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0007 to 0.0026]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7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5917266"/>
                  </a:ext>
                </a:extLst>
              </a:tr>
              <a:tr h="3244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nual income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e-06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-0.00000228 to 0.00000500]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2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8609465"/>
                  </a:ext>
                </a:extLst>
              </a:tr>
            </a:tbl>
          </a:graphicData>
        </a:graphic>
      </p:graphicFrame>
      <p:sp>
        <p:nvSpPr>
          <p:cNvPr id="6" name="CuadroTexto 5"/>
          <p:cNvSpPr txBox="1"/>
          <p:nvPr/>
        </p:nvSpPr>
        <p:spPr>
          <a:xfrm>
            <a:off x="665018" y="477982"/>
            <a:ext cx="98921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Material S5 </a:t>
            </a:r>
            <a:r>
              <a:rPr lang="en-US" dirty="0"/>
              <a:t>Multivariable linear regression of insulin dos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584676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0</Words>
  <Application>Microsoft Office PowerPoint</Application>
  <PresentationFormat>Panorámica</PresentationFormat>
  <Paragraphs>3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Mincho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</dc:creator>
  <cp:lastModifiedBy>Fernando</cp:lastModifiedBy>
  <cp:revision>4</cp:revision>
  <dcterms:created xsi:type="dcterms:W3CDTF">2025-07-22T12:35:43Z</dcterms:created>
  <dcterms:modified xsi:type="dcterms:W3CDTF">2026-02-20T10:49:58Z</dcterms:modified>
</cp:coreProperties>
</file>